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1416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23609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0801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6049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8024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0843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580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5717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011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3919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2792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66383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698C0-086C-447E-A53C-7FF244545B5A}" type="datetimeFigureOut">
              <a:rPr lang="es-ES" smtClean="0"/>
              <a:t>20/10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9C00B5-B6A8-46EB-A6D7-9C811FB387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143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10 CuadroTexto"/>
          <p:cNvSpPr txBox="1"/>
          <p:nvPr/>
        </p:nvSpPr>
        <p:spPr>
          <a:xfrm>
            <a:off x="755576" y="44624"/>
            <a:ext cx="7884368" cy="83099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ssification and Regression Tree (CRT) for </a:t>
            </a:r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D-L1 and CCRCC </a:t>
            </a:r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s’ </a:t>
            </a:r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-year overall survival (OS</a:t>
            </a:r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2"/>
          <a:srcRect l="6663" t="8854" b="7390"/>
          <a:stretch/>
        </p:blipFill>
        <p:spPr>
          <a:xfrm>
            <a:off x="1979712" y="1052736"/>
            <a:ext cx="5262808" cy="550570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</p:spTree>
    <p:extLst>
      <p:ext uri="{BB962C8B-B14F-4D97-AF65-F5344CB8AC3E}">
        <p14:creationId xmlns:p14="http://schemas.microsoft.com/office/powerpoint/2010/main" val="3874050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10 CuadroTexto"/>
          <p:cNvSpPr txBox="1"/>
          <p:nvPr/>
        </p:nvSpPr>
        <p:spPr>
          <a:xfrm>
            <a:off x="755576" y="44624"/>
            <a:ext cx="7884368" cy="830997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ssification and Regression Tree (CRT) for </a:t>
            </a:r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D-1 and CCRCC </a:t>
            </a:r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s’ </a:t>
            </a:r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-year overall survival (OS</a:t>
            </a:r>
            <a:r>
              <a:rPr lang="en-GB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/>
          <a:srcRect l="7727" t="7598" b="7569"/>
          <a:stretch/>
        </p:blipFill>
        <p:spPr>
          <a:xfrm>
            <a:off x="2051720" y="973716"/>
            <a:ext cx="4968552" cy="576765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</p:spTree>
    <p:extLst>
      <p:ext uri="{BB962C8B-B14F-4D97-AF65-F5344CB8AC3E}">
        <p14:creationId xmlns:p14="http://schemas.microsoft.com/office/powerpoint/2010/main" val="415038462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7</TotalTime>
  <Words>38</Words>
  <Application>Microsoft Office PowerPoint</Application>
  <PresentationFormat>Presentación en pantalla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SE IGNACIO LOPEZ FERNANDEZ DE VILLAVERDE</dc:creator>
  <cp:lastModifiedBy>GORKA LARRINAGA</cp:lastModifiedBy>
  <cp:revision>54</cp:revision>
  <dcterms:created xsi:type="dcterms:W3CDTF">2020-03-25T10:16:45Z</dcterms:created>
  <dcterms:modified xsi:type="dcterms:W3CDTF">2020-10-20T19:27:36Z</dcterms:modified>
</cp:coreProperties>
</file>